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144000" type="letter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A6FD1B0-51D3-42A5-AA7D-69582E791DD9}" v="149" dt="2021-05-20T13:50:08.50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19" d="100"/>
          <a:sy n="119" d="100"/>
        </p:scale>
        <p:origin x="15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ohnson, Eric T. - ARS" userId="5acbe24c-3fed-4a94-a6d2-eb3f4921ce84" providerId="ADAL" clId="{BA6FD1B0-51D3-42A5-AA7D-69582E791DD9}"/>
    <pc:docChg chg="undo addSld delSld modSld sldOrd">
      <pc:chgData name="Johnson, Eric T. - ARS" userId="5acbe24c-3fed-4a94-a6d2-eb3f4921ce84" providerId="ADAL" clId="{BA6FD1B0-51D3-42A5-AA7D-69582E791DD9}" dt="2021-05-25T15:38:04.248" v="302" actId="20577"/>
      <pc:docMkLst>
        <pc:docMk/>
      </pc:docMkLst>
      <pc:sldChg chg="addSp delSp modSp ord">
        <pc:chgData name="Johnson, Eric T. - ARS" userId="5acbe24c-3fed-4a94-a6d2-eb3f4921ce84" providerId="ADAL" clId="{BA6FD1B0-51D3-42A5-AA7D-69582E791DD9}" dt="2021-05-25T15:38:04.248" v="302" actId="20577"/>
        <pc:sldMkLst>
          <pc:docMk/>
          <pc:sldMk cId="891437252" sldId="256"/>
        </pc:sldMkLst>
        <pc:spChg chg="mod">
          <ac:chgData name="Johnson, Eric T. - ARS" userId="5acbe24c-3fed-4a94-a6d2-eb3f4921ce84" providerId="ADAL" clId="{BA6FD1B0-51D3-42A5-AA7D-69582E791DD9}" dt="2021-05-25T15:38:04.248" v="302" actId="20577"/>
          <ac:spMkLst>
            <pc:docMk/>
            <pc:sldMk cId="891437252" sldId="256"/>
            <ac:spMk id="4" creationId="{C542AF88-3F29-4AD9-A915-725997CC0E1D}"/>
          </ac:spMkLst>
        </pc:spChg>
        <pc:spChg chg="add del mod">
          <ac:chgData name="Johnson, Eric T. - ARS" userId="5acbe24c-3fed-4a94-a6d2-eb3f4921ce84" providerId="ADAL" clId="{BA6FD1B0-51D3-42A5-AA7D-69582E791DD9}" dt="2021-05-19T18:30:16.963" v="174"/>
          <ac:spMkLst>
            <pc:docMk/>
            <pc:sldMk cId="891437252" sldId="256"/>
            <ac:spMk id="9" creationId="{1EF73661-E71A-4C1D-8CBB-FBF1BC7EC774}"/>
          </ac:spMkLst>
        </pc:spChg>
        <pc:spChg chg="add del mod">
          <ac:chgData name="Johnson, Eric T. - ARS" userId="5acbe24c-3fed-4a94-a6d2-eb3f4921ce84" providerId="ADAL" clId="{BA6FD1B0-51D3-42A5-AA7D-69582E791DD9}" dt="2021-05-19T18:30:28.580" v="175"/>
          <ac:spMkLst>
            <pc:docMk/>
            <pc:sldMk cId="891437252" sldId="256"/>
            <ac:spMk id="10" creationId="{541813AA-2639-4075-9085-DAA9569789A1}"/>
          </ac:spMkLst>
        </pc:spChg>
        <pc:spChg chg="add del mod">
          <ac:chgData name="Johnson, Eric T. - ARS" userId="5acbe24c-3fed-4a94-a6d2-eb3f4921ce84" providerId="ADAL" clId="{BA6FD1B0-51D3-42A5-AA7D-69582E791DD9}" dt="2021-05-14T15:35:52.328" v="29" actId="767"/>
          <ac:spMkLst>
            <pc:docMk/>
            <pc:sldMk cId="891437252" sldId="256"/>
            <ac:spMk id="15" creationId="{1CDA54E1-A46F-4312-9FC9-4897162F9D57}"/>
          </ac:spMkLst>
        </pc:spChg>
        <pc:spChg chg="add mod">
          <ac:chgData name="Johnson, Eric T. - ARS" userId="5acbe24c-3fed-4a94-a6d2-eb3f4921ce84" providerId="ADAL" clId="{BA6FD1B0-51D3-42A5-AA7D-69582E791DD9}" dt="2021-05-19T18:33:05.310" v="189" actId="1076"/>
          <ac:spMkLst>
            <pc:docMk/>
            <pc:sldMk cId="891437252" sldId="256"/>
            <ac:spMk id="16" creationId="{2380DFA0-FA2A-4C7A-9793-A40C335C1478}"/>
          </ac:spMkLst>
        </pc:spChg>
        <pc:spChg chg="add mod">
          <ac:chgData name="Johnson, Eric T. - ARS" userId="5acbe24c-3fed-4a94-a6d2-eb3f4921ce84" providerId="ADAL" clId="{BA6FD1B0-51D3-42A5-AA7D-69582E791DD9}" dt="2021-05-19T18:33:21.646" v="194" actId="1076"/>
          <ac:spMkLst>
            <pc:docMk/>
            <pc:sldMk cId="891437252" sldId="256"/>
            <ac:spMk id="17" creationId="{6A40D420-D537-4B6F-9443-C27C3312E483}"/>
          </ac:spMkLst>
        </pc:spChg>
        <pc:spChg chg="add mod">
          <ac:chgData name="Johnson, Eric T. - ARS" userId="5acbe24c-3fed-4a94-a6d2-eb3f4921ce84" providerId="ADAL" clId="{BA6FD1B0-51D3-42A5-AA7D-69582E791DD9}" dt="2021-05-19T18:32:39.161" v="184" actId="1076"/>
          <ac:spMkLst>
            <pc:docMk/>
            <pc:sldMk cId="891437252" sldId="256"/>
            <ac:spMk id="18" creationId="{826C54DB-7487-4AE9-B1E1-8972D89C7700}"/>
          </ac:spMkLst>
        </pc:spChg>
        <pc:spChg chg="add mod">
          <ac:chgData name="Johnson, Eric T. - ARS" userId="5acbe24c-3fed-4a94-a6d2-eb3f4921ce84" providerId="ADAL" clId="{BA6FD1B0-51D3-42A5-AA7D-69582E791DD9}" dt="2021-05-19T18:32:43.154" v="185" actId="1076"/>
          <ac:spMkLst>
            <pc:docMk/>
            <pc:sldMk cId="891437252" sldId="256"/>
            <ac:spMk id="20" creationId="{B31A4959-411D-4269-BE70-64EA9605BA9C}"/>
          </ac:spMkLst>
        </pc:spChg>
        <pc:spChg chg="add mod">
          <ac:chgData name="Johnson, Eric T. - ARS" userId="5acbe24c-3fed-4a94-a6d2-eb3f4921ce84" providerId="ADAL" clId="{BA6FD1B0-51D3-42A5-AA7D-69582E791DD9}" dt="2021-05-19T18:35:18.769" v="210" actId="1076"/>
          <ac:spMkLst>
            <pc:docMk/>
            <pc:sldMk cId="891437252" sldId="256"/>
            <ac:spMk id="21" creationId="{FD11D148-FD5F-4CE3-B869-C22FB31CF17B}"/>
          </ac:spMkLst>
        </pc:spChg>
        <pc:spChg chg="add del mod">
          <ac:chgData name="Johnson, Eric T. - ARS" userId="5acbe24c-3fed-4a94-a6d2-eb3f4921ce84" providerId="ADAL" clId="{BA6FD1B0-51D3-42A5-AA7D-69582E791DD9}" dt="2021-05-19T15:11:51.426" v="137"/>
          <ac:spMkLst>
            <pc:docMk/>
            <pc:sldMk cId="891437252" sldId="256"/>
            <ac:spMk id="24" creationId="{790E9C68-5A57-4B6B-9B2F-9405CE1462C2}"/>
          </ac:spMkLst>
        </pc:spChg>
        <pc:picChg chg="add mod">
          <ac:chgData name="Johnson, Eric T. - ARS" userId="5acbe24c-3fed-4a94-a6d2-eb3f4921ce84" providerId="ADAL" clId="{BA6FD1B0-51D3-42A5-AA7D-69582E791DD9}" dt="2021-05-19T18:32:32.105" v="183" actId="1076"/>
          <ac:picMkLst>
            <pc:docMk/>
            <pc:sldMk cId="891437252" sldId="256"/>
            <ac:picMk id="3" creationId="{2E38D763-E174-4811-A3CC-CAEE30914F4E}"/>
          </ac:picMkLst>
        </pc:picChg>
        <pc:picChg chg="del">
          <ac:chgData name="Johnson, Eric T. - ARS" userId="5acbe24c-3fed-4a94-a6d2-eb3f4921ce84" providerId="ADAL" clId="{BA6FD1B0-51D3-42A5-AA7D-69582E791DD9}" dt="2021-05-19T18:29:48.983" v="173"/>
          <ac:picMkLst>
            <pc:docMk/>
            <pc:sldMk cId="891437252" sldId="256"/>
            <ac:picMk id="6" creationId="{474CF720-D20D-4E10-8562-3094B1C4478C}"/>
          </ac:picMkLst>
        </pc:picChg>
        <pc:picChg chg="mod">
          <ac:chgData name="Johnson, Eric T. - ARS" userId="5acbe24c-3fed-4a94-a6d2-eb3f4921ce84" providerId="ADAL" clId="{BA6FD1B0-51D3-42A5-AA7D-69582E791DD9}" dt="2021-05-19T18:31:35.106" v="182" actId="1076"/>
          <ac:picMkLst>
            <pc:docMk/>
            <pc:sldMk cId="891437252" sldId="256"/>
            <ac:picMk id="8" creationId="{6EF84CFC-202A-4F1F-8C79-8751736BE3F7}"/>
          </ac:picMkLst>
        </pc:picChg>
        <pc:picChg chg="add mod">
          <ac:chgData name="Johnson, Eric T. - ARS" userId="5acbe24c-3fed-4a94-a6d2-eb3f4921ce84" providerId="ADAL" clId="{BA6FD1B0-51D3-42A5-AA7D-69582E791DD9}" dt="2021-05-19T18:32:53.605" v="186" actId="1076"/>
          <ac:picMkLst>
            <pc:docMk/>
            <pc:sldMk cId="891437252" sldId="256"/>
            <ac:picMk id="12" creationId="{3A867066-9DAA-4C14-9B53-DF38C974E5A2}"/>
          </ac:picMkLst>
        </pc:picChg>
        <pc:picChg chg="add mod">
          <ac:chgData name="Johnson, Eric T. - ARS" userId="5acbe24c-3fed-4a94-a6d2-eb3f4921ce84" providerId="ADAL" clId="{BA6FD1B0-51D3-42A5-AA7D-69582E791DD9}" dt="2021-05-19T18:32:57.154" v="187" actId="1076"/>
          <ac:picMkLst>
            <pc:docMk/>
            <pc:sldMk cId="891437252" sldId="256"/>
            <ac:picMk id="14" creationId="{B87D2D4F-59DB-46EA-9D51-AFF58C002DF2}"/>
          </ac:picMkLst>
        </pc:picChg>
        <pc:picChg chg="add mod">
          <ac:chgData name="Johnson, Eric T. - ARS" userId="5acbe24c-3fed-4a94-a6d2-eb3f4921ce84" providerId="ADAL" clId="{BA6FD1B0-51D3-42A5-AA7D-69582E791DD9}" dt="2021-05-19T18:34:51.361" v="203" actId="1076"/>
          <ac:picMkLst>
            <pc:docMk/>
            <pc:sldMk cId="891437252" sldId="256"/>
            <ac:picMk id="15" creationId="{40F42A0E-D65B-4FB4-BA02-59E3BD870F06}"/>
          </ac:picMkLst>
        </pc:picChg>
        <pc:picChg chg="add mod">
          <ac:chgData name="Johnson, Eric T. - ARS" userId="5acbe24c-3fed-4a94-a6d2-eb3f4921ce84" providerId="ADAL" clId="{BA6FD1B0-51D3-42A5-AA7D-69582E791DD9}" dt="2021-05-19T18:34:53.534" v="204" actId="1076"/>
          <ac:picMkLst>
            <pc:docMk/>
            <pc:sldMk cId="891437252" sldId="256"/>
            <ac:picMk id="19" creationId="{62C356EF-E8CD-40B3-90D1-4CC9D2F5BFBD}"/>
          </ac:picMkLst>
        </pc:picChg>
        <pc:picChg chg="add del mod">
          <ac:chgData name="Johnson, Eric T. - ARS" userId="5acbe24c-3fed-4a94-a6d2-eb3f4921ce84" providerId="ADAL" clId="{BA6FD1B0-51D3-42A5-AA7D-69582E791DD9}" dt="2021-05-19T15:10:27.598" v="130"/>
          <ac:picMkLst>
            <pc:docMk/>
            <pc:sldMk cId="891437252" sldId="256"/>
            <ac:picMk id="19" creationId="{8C639133-493F-428C-92BC-E4C6902ED45E}"/>
          </ac:picMkLst>
        </pc:picChg>
        <pc:picChg chg="add del mod">
          <ac:chgData name="Johnson, Eric T. - ARS" userId="5acbe24c-3fed-4a94-a6d2-eb3f4921ce84" providerId="ADAL" clId="{BA6FD1B0-51D3-42A5-AA7D-69582E791DD9}" dt="2021-05-14T15:42:19.740" v="67" actId="931"/>
          <ac:picMkLst>
            <pc:docMk/>
            <pc:sldMk cId="891437252" sldId="256"/>
            <ac:picMk id="21" creationId="{3CA0FDB8-1A56-4BCD-8B63-1FEF08024D4E}"/>
          </ac:picMkLst>
        </pc:picChg>
        <pc:picChg chg="add del mod">
          <ac:chgData name="Johnson, Eric T. - ARS" userId="5acbe24c-3fed-4a94-a6d2-eb3f4921ce84" providerId="ADAL" clId="{BA6FD1B0-51D3-42A5-AA7D-69582E791DD9}" dt="2021-05-19T15:10:52.589" v="132"/>
          <ac:picMkLst>
            <pc:docMk/>
            <pc:sldMk cId="891437252" sldId="256"/>
            <ac:picMk id="23" creationId="{3D7530B6-EF07-4102-ABBF-855F4C5E62FD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22510-DBE7-4CD1-AC25-FA22AD457A1B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5AA5C-CEBB-4313-AEAF-79099D5590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54034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22510-DBE7-4CD1-AC25-FA22AD457A1B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5AA5C-CEBB-4313-AEAF-79099D5590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76254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22510-DBE7-4CD1-AC25-FA22AD457A1B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5AA5C-CEBB-4313-AEAF-79099D5590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15952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22510-DBE7-4CD1-AC25-FA22AD457A1B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5AA5C-CEBB-4313-AEAF-79099D5590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8837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22510-DBE7-4CD1-AC25-FA22AD457A1B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5AA5C-CEBB-4313-AEAF-79099D5590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29844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22510-DBE7-4CD1-AC25-FA22AD457A1B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5AA5C-CEBB-4313-AEAF-79099D5590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72947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22510-DBE7-4CD1-AC25-FA22AD457A1B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5AA5C-CEBB-4313-AEAF-79099D5590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5562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22510-DBE7-4CD1-AC25-FA22AD457A1B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5AA5C-CEBB-4313-AEAF-79099D5590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62861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22510-DBE7-4CD1-AC25-FA22AD457A1B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5AA5C-CEBB-4313-AEAF-79099D5590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5530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22510-DBE7-4CD1-AC25-FA22AD457A1B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5AA5C-CEBB-4313-AEAF-79099D5590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5778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22510-DBE7-4CD1-AC25-FA22AD457A1B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35AA5C-CEBB-4313-AEAF-79099D5590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1951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922510-DBE7-4CD1-AC25-FA22AD457A1B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35AA5C-CEBB-4313-AEAF-79099D5590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23500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542AF88-3F29-4AD9-A915-725997CC0E1D}"/>
              </a:ext>
            </a:extLst>
          </p:cNvPr>
          <p:cNvSpPr txBox="1"/>
          <p:nvPr/>
        </p:nvSpPr>
        <p:spPr>
          <a:xfrm>
            <a:off x="502832" y="562142"/>
            <a:ext cx="545604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pplementary File 2.  Representative assay of </a:t>
            </a:r>
            <a:r>
              <a:rPr lang="en-US" sz="1200" i="1" dirty="0"/>
              <a:t>P</a:t>
            </a:r>
            <a:r>
              <a:rPr lang="en-US" sz="1200" dirty="0"/>
              <a:t>. </a:t>
            </a:r>
            <a:r>
              <a:rPr lang="en-US" sz="1200" i="1" dirty="0" err="1"/>
              <a:t>belbahrii</a:t>
            </a:r>
            <a:r>
              <a:rPr lang="en-US" sz="1200" dirty="0"/>
              <a:t> inoculation of basil leaves</a:t>
            </a:r>
          </a:p>
          <a:p>
            <a:r>
              <a:rPr lang="en-US" sz="1200" dirty="0"/>
              <a:t>as performed in </a:t>
            </a:r>
            <a:r>
              <a:rPr lang="en-US" sz="1200"/>
              <a:t>the manuscript.</a:t>
            </a:r>
            <a:endParaRPr lang="en-US" sz="1200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6EF84CFC-202A-4F1F-8C79-8751736BE3F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2225" y="1354058"/>
            <a:ext cx="2560035" cy="170669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3A867066-9DAA-4C14-9B53-DF38C974E5A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3411" y="3648758"/>
            <a:ext cx="2601739" cy="1846483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B87D2D4F-59DB-46EA-9D51-AFF58C002DF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9736" y="3648758"/>
            <a:ext cx="2484016" cy="1846482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2380DFA0-FA2A-4C7A-9793-A40C335C1478}"/>
              </a:ext>
            </a:extLst>
          </p:cNvPr>
          <p:cNvSpPr txBox="1"/>
          <p:nvPr/>
        </p:nvSpPr>
        <p:spPr>
          <a:xfrm>
            <a:off x="859802" y="5638192"/>
            <a:ext cx="186461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/>
              <a:t>Leaves treated with spores 6 </a:t>
            </a:r>
            <a:r>
              <a:rPr lang="en-US" sz="1000" err="1"/>
              <a:t>dai</a:t>
            </a:r>
            <a:endParaRPr lang="en-US" sz="100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A40D420-D537-4B6F-9443-C27C3312E483}"/>
              </a:ext>
            </a:extLst>
          </p:cNvPr>
          <p:cNvSpPr txBox="1"/>
          <p:nvPr/>
        </p:nvSpPr>
        <p:spPr>
          <a:xfrm>
            <a:off x="3671231" y="5638191"/>
            <a:ext cx="17620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/>
              <a:t>Leaves with sterile water 6 </a:t>
            </a:r>
            <a:r>
              <a:rPr lang="en-US" sz="1000" err="1"/>
              <a:t>dai</a:t>
            </a:r>
            <a:endParaRPr lang="en-US" sz="100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E38D763-E174-4811-A3CC-CAEE30914F4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6854" y="1354058"/>
            <a:ext cx="2570346" cy="1713564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826C54DB-7487-4AE9-B1E1-8972D89C7700}"/>
              </a:ext>
            </a:extLst>
          </p:cNvPr>
          <p:cNvSpPr txBox="1"/>
          <p:nvPr/>
        </p:nvSpPr>
        <p:spPr>
          <a:xfrm>
            <a:off x="859802" y="3171709"/>
            <a:ext cx="186461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/>
              <a:t>Leaves treated with spores 3 </a:t>
            </a:r>
            <a:r>
              <a:rPr lang="en-US" sz="1000" err="1"/>
              <a:t>dai</a:t>
            </a:r>
            <a:endParaRPr lang="en-US" sz="100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31A4959-411D-4269-BE70-64EA9605BA9C}"/>
              </a:ext>
            </a:extLst>
          </p:cNvPr>
          <p:cNvSpPr txBox="1"/>
          <p:nvPr/>
        </p:nvSpPr>
        <p:spPr>
          <a:xfrm>
            <a:off x="3511330" y="3171709"/>
            <a:ext cx="17620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/>
              <a:t>Leaves with sterile water 3 </a:t>
            </a:r>
            <a:r>
              <a:rPr lang="en-US" sz="1000" err="1"/>
              <a:t>dai</a:t>
            </a:r>
            <a:endParaRPr lang="en-US" sz="1000"/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40F42A0E-D65B-4FB4-BA02-59E3BD870F0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3411" y="6076377"/>
            <a:ext cx="2601739" cy="1734493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62C356EF-E8CD-40B3-90D1-4CC9D2F5BFBD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0874" y="6083250"/>
            <a:ext cx="2601740" cy="1734493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FD11D148-FD5F-4CE3-B869-C22FB31CF17B}"/>
              </a:ext>
            </a:extLst>
          </p:cNvPr>
          <p:cNvSpPr txBox="1"/>
          <p:nvPr/>
        </p:nvSpPr>
        <p:spPr>
          <a:xfrm>
            <a:off x="1792108" y="7893470"/>
            <a:ext cx="33233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/>
              <a:t>Closeup of leaves 6 </a:t>
            </a:r>
            <a:r>
              <a:rPr lang="en-US" sz="1000" err="1"/>
              <a:t>dai</a:t>
            </a:r>
            <a:r>
              <a:rPr lang="en-US" sz="1000"/>
              <a:t> with downy mildew sporangiophores</a:t>
            </a:r>
          </a:p>
        </p:txBody>
      </p:sp>
    </p:spTree>
    <p:extLst>
      <p:ext uri="{BB962C8B-B14F-4D97-AF65-F5344CB8AC3E}">
        <p14:creationId xmlns:p14="http://schemas.microsoft.com/office/powerpoint/2010/main" val="8914372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5BE4C3174F4424EADC49FC3556F521E" ma:contentTypeVersion="6" ma:contentTypeDescription="Create a new document." ma:contentTypeScope="" ma:versionID="17331685ba584bbf7f22054a744bf070">
  <xsd:schema xmlns:xsd="http://www.w3.org/2001/XMLSchema" xmlns:xs="http://www.w3.org/2001/XMLSchema" xmlns:p="http://schemas.microsoft.com/office/2006/metadata/properties" xmlns:ns3="7ce2b379-4925-4579-9e36-65a705efa73e" xmlns:ns4="823f798c-fd86-46be-a45f-049a2fe59d6e" targetNamespace="http://schemas.microsoft.com/office/2006/metadata/properties" ma:root="true" ma:fieldsID="9aea9154199c37f2f31ffbeec18cf2b0" ns3:_="" ns4:_="">
    <xsd:import namespace="7ce2b379-4925-4579-9e36-65a705efa73e"/>
    <xsd:import namespace="823f798c-fd86-46be-a45f-049a2fe59d6e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ce2b379-4925-4579-9e36-65a705efa73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3" nillable="true" ma:displayName="MediaServiceDateTaken" ma:hidden="true" ma:internalName="MediaServiceDateTake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23f798c-fd86-46be-a45f-049a2fe59d6e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C2F81B4A-25A6-440F-8F04-F05C6113367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ce2b379-4925-4579-9e36-65a705efa73e"/>
    <ds:schemaRef ds:uri="823f798c-fd86-46be-a45f-049a2fe59d6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69B1FD72-F609-4C97-91AD-02425BB2BC94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3.xml><?xml version="1.0" encoding="utf-8"?>
<ds:datastoreItem xmlns:ds="http://schemas.openxmlformats.org/officeDocument/2006/customXml" ds:itemID="{5B4A0B38-B042-4553-8DF7-F2A570247014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3</Words>
  <Application>Microsoft Office PowerPoint</Application>
  <PresentationFormat>Letter Paper (8.5x11 in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son, Eric T. - ARS</dc:creator>
  <cp:lastModifiedBy>Johnson, Eric T. - ARS</cp:lastModifiedBy>
  <cp:revision>1</cp:revision>
  <cp:lastPrinted>2021-05-19T22:14:38Z</cp:lastPrinted>
  <dcterms:created xsi:type="dcterms:W3CDTF">2021-05-14T14:59:48Z</dcterms:created>
  <dcterms:modified xsi:type="dcterms:W3CDTF">2021-05-25T15:38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5BE4C3174F4424EADC49FC3556F521E</vt:lpwstr>
  </property>
</Properties>
</file>